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60" r:id="rId3"/>
  </p:sldIdLst>
  <p:sldSz cx="12192000" cy="6858000"/>
  <p:notesSz cx="6858000" cy="9144000"/>
  <p:defaultTextStyle>
    <a:defPPr>
      <a:defRPr lang="ko-KR"/>
    </a:defPPr>
    <a:lvl1pPr marL="0" algn="l" defTabSz="91427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34" algn="l" defTabSz="91427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70" algn="l" defTabSz="91427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406" algn="l" defTabSz="91427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540" algn="l" defTabSz="91427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675" algn="l" defTabSz="91427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810" algn="l" defTabSz="91427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946" algn="l" defTabSz="91427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081" algn="l" defTabSz="91427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6357" autoAdjust="0"/>
  </p:normalViewPr>
  <p:slideViewPr>
    <p:cSldViewPr snapToGrid="0">
      <p:cViewPr varScale="1">
        <p:scale>
          <a:sx n="79" d="100"/>
          <a:sy n="79" d="100"/>
        </p:scale>
        <p:origin x="120" y="6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2019\&#49892;&#54744;\0.&#54861;&#49340;&#45796;&#45817;&#52404;\&#44036;&#48372;&#54840;\GalN\HPT19-004\&#54792;&#50529;\GAL%20&#45796;&#45817;&#52404;%20&#54792;&#50529;%20&#44036;&#51648;&#54364;%203&#52264;%2020190819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2019\&#49892;&#54744;\0.&#54861;&#49340;&#45796;&#45817;&#52404;\&#44036;&#48372;&#54840;\GalN\HPT19-004\TBARS\TBARS%20Doubl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2019\&#49892;&#54744;\0.&#54861;&#49340;&#45796;&#45817;&#52404;\&#44036;&#48372;&#54840;\GalN\HPT19-004\SOD\190830_SOD%20&#52769;&#51221;&#44050;%20&#52572;&#51333;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E:\2019\&#49892;&#54744;\0.&#54861;&#49340;&#45796;&#45817;&#52404;\&#44036;&#48372;&#54840;\GalN\HPT19-004\Gpx\GPX%2020190905%201500%20g%20&#49345;&#52789;&#50529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Lbls>
            <c:dLbl>
              <c:idx val="1"/>
              <c:layout>
                <c:manualLayout>
                  <c:x val="-1.7383600479773198E-3"/>
                  <c:y val="-0.12034827044025158"/>
                </c:manualLayout>
              </c:layout>
              <c:tx>
                <c:rich>
                  <a:bodyPr/>
                  <a:lstStyle/>
                  <a:p>
                    <a:pPr>
                      <a:defRPr/>
                    </a:pPr>
                    <a:r>
                      <a:rPr lang="en-US"/>
                      <a:t>***</a:t>
                    </a:r>
                  </a:p>
                </c:rich>
              </c:tx>
              <c:spPr>
                <a:noFill/>
                <a:ln w="25400">
                  <a:noFill/>
                </a:ln>
              </c:sp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0-F396-4BED-846A-711242A64071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-6.3469262799550117E-17"/>
                  <c:y val="-9.9842767295597545E-2"/>
                </c:manualLayout>
              </c:layout>
              <c:tx>
                <c:rich>
                  <a:bodyPr/>
                  <a:lstStyle/>
                  <a:p>
                    <a:pPr>
                      <a:defRPr/>
                    </a:pPr>
                    <a:r>
                      <a:rPr lang="en-US"/>
                      <a:t>#</a:t>
                    </a:r>
                  </a:p>
                </c:rich>
              </c:tx>
              <c:spPr>
                <a:noFill/>
                <a:ln w="25400">
                  <a:noFill/>
                </a:ln>
              </c:sp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1-F396-4BED-846A-711242A64071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0"/>
                  <c:y val="-5.3249475890985325E-2"/>
                </c:manualLayout>
              </c:layout>
              <c:tx>
                <c:rich>
                  <a:bodyPr/>
                  <a:lstStyle/>
                  <a:p>
                    <a:pPr>
                      <a:defRPr/>
                    </a:pPr>
                    <a:r>
                      <a:rPr lang="en-US"/>
                      <a:t>#</a:t>
                    </a:r>
                  </a:p>
                </c:rich>
              </c:tx>
              <c:spPr>
                <a:noFill/>
                <a:ln w="25400">
                  <a:noFill/>
                </a:ln>
              </c:sp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2-F396-4BED-846A-711242A64071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0"/>
            <c:showCatName val="0"/>
            <c:showSerName val="0"/>
            <c:showPercent val="0"/>
            <c:showBubbleSize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Final!$AE$8:$AE$14</c:f>
                <c:numCache>
                  <c:formatCode>General</c:formatCode>
                  <c:ptCount val="7"/>
                  <c:pt idx="0">
                    <c:v>18.711998527385816</c:v>
                  </c:pt>
                  <c:pt idx="1">
                    <c:v>2047.2372983011899</c:v>
                  </c:pt>
                  <c:pt idx="2">
                    <c:v>1710.7251548847803</c:v>
                  </c:pt>
                  <c:pt idx="3">
                    <c:v>912.24387577494258</c:v>
                  </c:pt>
                  <c:pt idx="4">
                    <c:v>2534.4410955211933</c:v>
                  </c:pt>
                  <c:pt idx="5">
                    <c:v>2753.9633056540329</c:v>
                  </c:pt>
                  <c:pt idx="6">
                    <c:v>2861.1481524031574</c:v>
                  </c:pt>
                </c:numCache>
              </c:numRef>
            </c:plus>
          </c:errBars>
          <c:cat>
            <c:strRef>
              <c:f>Final!$AJ$129:$AJ$134</c:f>
              <c:strCache>
                <c:ptCount val="6"/>
                <c:pt idx="0">
                  <c:v>Normal</c:v>
                </c:pt>
                <c:pt idx="1">
                  <c:v>GalN</c:v>
                </c:pt>
                <c:pt idx="2">
                  <c:v>Milk thistle 100</c:v>
                </c:pt>
                <c:pt idx="3">
                  <c:v>NSF 25</c:v>
                </c:pt>
                <c:pt idx="4">
                  <c:v>NSF 50</c:v>
                </c:pt>
                <c:pt idx="5">
                  <c:v>NSF 100</c:v>
                </c:pt>
              </c:strCache>
            </c:strRef>
          </c:cat>
          <c:val>
            <c:numRef>
              <c:f>Final!$X$8:$X$13</c:f>
              <c:numCache>
                <c:formatCode>0.0</c:formatCode>
                <c:ptCount val="6"/>
                <c:pt idx="0">
                  <c:v>151.83333333333334</c:v>
                </c:pt>
                <c:pt idx="1">
                  <c:v>10131.666666666666</c:v>
                </c:pt>
                <c:pt idx="2">
                  <c:v>7021.666666666667</c:v>
                </c:pt>
                <c:pt idx="3">
                  <c:v>7043.333333333333</c:v>
                </c:pt>
                <c:pt idx="4">
                  <c:v>9595</c:v>
                </c:pt>
                <c:pt idx="5">
                  <c:v>7798.3333333333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F396-4BED-846A-711242A640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764939632"/>
        <c:axId val="1764945072"/>
      </c:barChart>
      <c:catAx>
        <c:axId val="17649396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+mn-lt"/>
              </a:defRPr>
            </a:pPr>
            <a:endParaRPr lang="ko-KR"/>
          </a:p>
        </c:txPr>
        <c:crossAx val="1764945072"/>
        <c:crosses val="autoZero"/>
        <c:auto val="1"/>
        <c:lblAlgn val="ctr"/>
        <c:lblOffset val="100"/>
        <c:noMultiLvlLbl val="0"/>
      </c:catAx>
      <c:valAx>
        <c:axId val="17649450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Serum AST (IU/L)</a:t>
                </a:r>
                <a:endParaRPr lang="ko-KR" sz="1100"/>
              </a:p>
            </c:rich>
          </c:tx>
          <c:layout/>
          <c:overlay val="0"/>
        </c:title>
        <c:numFmt formatCode="#,##0_);[Red]\(#,##0\)" sourceLinked="0"/>
        <c:majorTickMark val="out"/>
        <c:minorTickMark val="none"/>
        <c:tickLblPos val="nextTo"/>
        <c:crossAx val="176493963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+mn-lt"/>
          <a:ea typeface="KT&amp;G 상상본문 L" panose="02000300000000000000" pitchFamily="2" charset="-127"/>
        </a:defRPr>
      </a:pPr>
      <a:endParaRPr lang="ko-K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Lbls>
            <c:dLbl>
              <c:idx val="1"/>
              <c:layout>
                <c:manualLayout>
                  <c:x val="-1.738380896722761E-3"/>
                  <c:y val="-8.3795886136393785E-2"/>
                </c:manualLayout>
              </c:layout>
              <c:tx>
                <c:rich>
                  <a:bodyPr/>
                  <a:lstStyle/>
                  <a:p>
                    <a:pPr>
                      <a:defRPr/>
                    </a:pPr>
                    <a:r>
                      <a:rPr lang="en-US"/>
                      <a:t>*</a:t>
                    </a:r>
                  </a:p>
                </c:rich>
              </c:tx>
              <c:spPr>
                <a:noFill/>
                <a:ln w="25400">
                  <a:noFill/>
                </a:ln>
              </c:sp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0-BD26-4AAB-A7AE-A0631E06EC1D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0"/>
                  <c:y val="-5.9967461261475292E-2"/>
                </c:manualLayout>
              </c:layout>
              <c:tx>
                <c:rich>
                  <a:bodyPr/>
                  <a:lstStyle/>
                  <a:p>
                    <a:pPr>
                      <a:defRPr/>
                    </a:pPr>
                    <a:r>
                      <a:rPr lang="en-US"/>
                      <a:t>#</a:t>
                    </a:r>
                  </a:p>
                </c:rich>
              </c:tx>
              <c:spPr>
                <a:noFill/>
                <a:ln w="25400">
                  <a:noFill/>
                </a:ln>
              </c:sp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1-BD26-4AAB-A7AE-A0631E06EC1D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0"/>
                  <c:y val="-8.9801789996928227E-2"/>
                </c:manualLayout>
              </c:layout>
              <c:tx>
                <c:rich>
                  <a:bodyPr/>
                  <a:lstStyle/>
                  <a:p>
                    <a:pPr>
                      <a:defRPr/>
                    </a:pPr>
                    <a:r>
                      <a:rPr lang="en-US"/>
                      <a:t>#</a:t>
                    </a:r>
                  </a:p>
                </c:rich>
              </c:tx>
              <c:spPr>
                <a:noFill/>
                <a:ln w="25400">
                  <a:noFill/>
                </a:ln>
              </c:sp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2-BD26-4AAB-A7AE-A0631E06EC1D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0"/>
                  <c:y val="-0.10301142937581409"/>
                </c:manualLayout>
              </c:layout>
              <c:tx>
                <c:rich>
                  <a:bodyPr/>
                  <a:lstStyle/>
                  <a:p>
                    <a:r>
                      <a:rPr lang="en-US" altLang="ko-KR"/>
                      <a:t>#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3-BD26-4AAB-A7AE-A0631E06EC1D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1.269002486595239E-16"/>
                  <c:y val="-0.10633437871051774"/>
                </c:manualLayout>
              </c:layout>
              <c:tx>
                <c:rich>
                  <a:bodyPr/>
                  <a:lstStyle/>
                  <a:p>
                    <a:r>
                      <a:rPr lang="en-US" altLang="ko-KR"/>
                      <a:t>#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4-BD26-4AAB-A7AE-A0631E06EC1D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0"/>
            <c:showCatName val="0"/>
            <c:showSerName val="0"/>
            <c:showPercent val="0"/>
            <c:showBubbleSize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Analysis!$O$62:$T$62</c:f>
                <c:numCache>
                  <c:formatCode>General</c:formatCode>
                  <c:ptCount val="6"/>
                  <c:pt idx="0">
                    <c:v>1.3206133301002259</c:v>
                  </c:pt>
                  <c:pt idx="1">
                    <c:v>0.83826272614629926</c:v>
                  </c:pt>
                  <c:pt idx="2">
                    <c:v>0.60852002550268081</c:v>
                  </c:pt>
                  <c:pt idx="3">
                    <c:v>1.0019358111590213</c:v>
                  </c:pt>
                  <c:pt idx="4">
                    <c:v>0.92000130782780287</c:v>
                  </c:pt>
                  <c:pt idx="5">
                    <c:v>1.16911155789247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Analysis!$H$101:$M$101</c:f>
              <c:strCache>
                <c:ptCount val="6"/>
                <c:pt idx="0">
                  <c:v>Normal</c:v>
                </c:pt>
                <c:pt idx="1">
                  <c:v>GalN</c:v>
                </c:pt>
                <c:pt idx="2">
                  <c:v>Milk thistle 100</c:v>
                </c:pt>
                <c:pt idx="3">
                  <c:v>NSF 25</c:v>
                </c:pt>
                <c:pt idx="4">
                  <c:v>NSF 50</c:v>
                </c:pt>
                <c:pt idx="5">
                  <c:v>NSF 100</c:v>
                </c:pt>
              </c:strCache>
            </c:strRef>
          </c:cat>
          <c:val>
            <c:numRef>
              <c:f>Analysis!$O$61:$T$61</c:f>
              <c:numCache>
                <c:formatCode>0.0000</c:formatCode>
                <c:ptCount val="6"/>
                <c:pt idx="0">
                  <c:v>3.8824319672131153</c:v>
                </c:pt>
                <c:pt idx="1">
                  <c:v>6.2888622950819686</c:v>
                </c:pt>
                <c:pt idx="2">
                  <c:v>5.1707229508196733</c:v>
                </c:pt>
                <c:pt idx="3">
                  <c:v>4.8498655737704928</c:v>
                </c:pt>
                <c:pt idx="4">
                  <c:v>5.0102942622950826</c:v>
                </c:pt>
                <c:pt idx="5">
                  <c:v>4.543592622950819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BD26-4AAB-A7AE-A0631E06EC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764940176"/>
        <c:axId val="1764943984"/>
      </c:barChart>
      <c:catAx>
        <c:axId val="17649401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+mn-lt"/>
              </a:defRPr>
            </a:pPr>
            <a:endParaRPr lang="ko-KR"/>
          </a:p>
        </c:txPr>
        <c:crossAx val="1764943984"/>
        <c:crosses val="autoZero"/>
        <c:auto val="1"/>
        <c:lblAlgn val="ctr"/>
        <c:lblOffset val="100"/>
        <c:noMultiLvlLbl val="0"/>
      </c:catAx>
      <c:valAx>
        <c:axId val="17649439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Liver MDA (</a:t>
                </a:r>
                <a:r>
                  <a:rPr lang="el-GR" sz="1100"/>
                  <a:t>μ</a:t>
                </a:r>
                <a:r>
                  <a:rPr lang="en-US" sz="1100"/>
                  <a:t>M/mg)</a:t>
                </a:r>
                <a:endParaRPr lang="ko-KR" sz="1100"/>
              </a:p>
            </c:rich>
          </c:tx>
          <c:layout/>
          <c:overlay val="0"/>
        </c:title>
        <c:numFmt formatCode="#,##0_);[Red]\(#,##0\)" sourceLinked="0"/>
        <c:majorTickMark val="out"/>
        <c:minorTickMark val="none"/>
        <c:tickLblPos val="nextTo"/>
        <c:crossAx val="176494017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+mn-lt"/>
          <a:ea typeface="KT&amp;G 상상본문 L" panose="02000300000000000000" pitchFamily="2" charset="-127"/>
        </a:defRPr>
      </a:pPr>
      <a:endParaRPr lang="ko-K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Lbls>
            <c:dLbl>
              <c:idx val="1"/>
              <c:layout>
                <c:manualLayout>
                  <c:x val="-1.738380896722761E-3"/>
                  <c:y val="-8.3795886136393785E-2"/>
                </c:manualLayout>
              </c:layout>
              <c:tx>
                <c:rich>
                  <a:bodyPr/>
                  <a:lstStyle/>
                  <a:p>
                    <a:pPr>
                      <a:defRPr/>
                    </a:pPr>
                    <a:r>
                      <a:rPr lang="en-US"/>
                      <a:t>*</a:t>
                    </a:r>
                  </a:p>
                </c:rich>
              </c:tx>
              <c:spPr>
                <a:noFill/>
                <a:ln w="25400">
                  <a:noFill/>
                </a:ln>
              </c:sp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0-5A02-4B29-9BF1-105C65B06287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0"/>
                  <c:y val="-5.9967461261475292E-2"/>
                </c:manualLayout>
              </c:layout>
              <c:tx>
                <c:rich>
                  <a:bodyPr/>
                  <a:lstStyle/>
                  <a:p>
                    <a:pPr>
                      <a:defRPr/>
                    </a:pPr>
                    <a:r>
                      <a:rPr lang="en-US"/>
                      <a:t>#</a:t>
                    </a:r>
                  </a:p>
                </c:rich>
              </c:tx>
              <c:spPr>
                <a:noFill/>
                <a:ln w="25400">
                  <a:noFill/>
                </a:ln>
              </c:sp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1-5A02-4B29-9BF1-105C65B06287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0"/>
                  <c:y val="-6.6541144654002474E-2"/>
                </c:manualLayout>
              </c:layout>
              <c:tx>
                <c:rich>
                  <a:bodyPr/>
                  <a:lstStyle/>
                  <a:p>
                    <a:pPr>
                      <a:defRPr/>
                    </a:pPr>
                    <a:r>
                      <a:rPr lang="en-US"/>
                      <a:t>#</a:t>
                    </a:r>
                  </a:p>
                </c:rich>
              </c:tx>
              <c:spPr>
                <a:noFill/>
                <a:ln w="25400">
                  <a:noFill/>
                </a:ln>
              </c:sp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2-5A02-4B29-9BF1-105C65B06287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0"/>
                  <c:y val="-0.10301142937581409"/>
                </c:manualLayout>
              </c:layout>
              <c:tx>
                <c:rich>
                  <a:bodyPr/>
                  <a:lstStyle/>
                  <a:p>
                    <a:r>
                      <a:rPr lang="en-US" altLang="ko-KR"/>
                      <a:t>#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3-5A02-4B29-9BF1-105C65B06287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1.7304779266639806E-3"/>
                  <c:y val="-9.6365530706406702E-2"/>
                </c:manualLayout>
              </c:layout>
              <c:tx>
                <c:rich>
                  <a:bodyPr/>
                  <a:lstStyle/>
                  <a:p>
                    <a:r>
                      <a:rPr lang="en-US" altLang="ko-KR"/>
                      <a:t>#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4-5A02-4B29-9BF1-105C65B06287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0"/>
            <c:showCatName val="0"/>
            <c:showSerName val="0"/>
            <c:showPercent val="0"/>
            <c:showBubbleSize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Analysis!$X$76:$AC$76</c:f>
                <c:numCache>
                  <c:formatCode>General</c:formatCode>
                  <c:ptCount val="6"/>
                  <c:pt idx="0">
                    <c:v>22.687332866779446</c:v>
                  </c:pt>
                  <c:pt idx="1">
                    <c:v>11.724807523947645</c:v>
                  </c:pt>
                  <c:pt idx="2">
                    <c:v>9.5989500301237918</c:v>
                  </c:pt>
                  <c:pt idx="3">
                    <c:v>11.702298019420303</c:v>
                  </c:pt>
                  <c:pt idx="4">
                    <c:v>16.084873262536892</c:v>
                  </c:pt>
                  <c:pt idx="5">
                    <c:v>12.574404546403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Analysis!$H$110:$M$110</c:f>
              <c:strCache>
                <c:ptCount val="6"/>
                <c:pt idx="0">
                  <c:v>Normal</c:v>
                </c:pt>
                <c:pt idx="1">
                  <c:v>GalN</c:v>
                </c:pt>
                <c:pt idx="2">
                  <c:v>Milk thistle 100</c:v>
                </c:pt>
                <c:pt idx="3">
                  <c:v>NSF 25</c:v>
                </c:pt>
                <c:pt idx="4">
                  <c:v>NSF 50</c:v>
                </c:pt>
                <c:pt idx="5">
                  <c:v>NSF 100</c:v>
                </c:pt>
              </c:strCache>
            </c:strRef>
          </c:cat>
          <c:val>
            <c:numRef>
              <c:f>Analysis!$X$75:$AC$75</c:f>
              <c:numCache>
                <c:formatCode>0.0</c:formatCode>
                <c:ptCount val="6"/>
                <c:pt idx="0">
                  <c:v>84.638811965288937</c:v>
                </c:pt>
                <c:pt idx="1">
                  <c:v>49.59565250659967</c:v>
                </c:pt>
                <c:pt idx="2">
                  <c:v>65.616564063401228</c:v>
                </c:pt>
                <c:pt idx="3">
                  <c:v>66.298636552433663</c:v>
                </c:pt>
                <c:pt idx="4">
                  <c:v>77.375568570613865</c:v>
                </c:pt>
                <c:pt idx="5">
                  <c:v>71.96690304181525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5A02-4B29-9BF1-105C65B062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764945616"/>
        <c:axId val="1764946704"/>
      </c:barChart>
      <c:catAx>
        <c:axId val="17649456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+mn-lt"/>
              </a:defRPr>
            </a:pPr>
            <a:endParaRPr lang="ko-KR"/>
          </a:p>
        </c:txPr>
        <c:crossAx val="1764946704"/>
        <c:crosses val="autoZero"/>
        <c:auto val="1"/>
        <c:lblAlgn val="ctr"/>
        <c:lblOffset val="100"/>
        <c:noMultiLvlLbl val="0"/>
      </c:catAx>
      <c:valAx>
        <c:axId val="176494670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Liver SOD (U/ml/mg)</a:t>
                </a:r>
                <a:endParaRPr lang="ko-KR" sz="1100"/>
              </a:p>
            </c:rich>
          </c:tx>
          <c:layout/>
          <c:overlay val="0"/>
        </c:title>
        <c:numFmt formatCode="#,##0_);[Red]\(#,##0\)" sourceLinked="0"/>
        <c:majorTickMark val="out"/>
        <c:minorTickMark val="none"/>
        <c:tickLblPos val="nextTo"/>
        <c:crossAx val="176494561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+mn-lt"/>
          <a:ea typeface="KT&amp;G 상상본문 L" panose="02000300000000000000" pitchFamily="2" charset="-127"/>
        </a:defRPr>
      </a:pPr>
      <a:endParaRPr lang="ko-KR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Lbls>
            <c:dLbl>
              <c:idx val="1"/>
              <c:layout>
                <c:manualLayout>
                  <c:x val="-7.9029700587803833E-6"/>
                  <c:y val="-9.044178480580109E-2"/>
                </c:manualLayout>
              </c:layout>
              <c:tx>
                <c:rich>
                  <a:bodyPr/>
                  <a:lstStyle/>
                  <a:p>
                    <a:pPr>
                      <a:defRPr/>
                    </a:pPr>
                    <a:r>
                      <a:rPr lang="en-US"/>
                      <a:t>*</a:t>
                    </a:r>
                  </a:p>
                </c:rich>
              </c:tx>
              <c:spPr>
                <a:noFill/>
                <a:ln w="25400">
                  <a:noFill/>
                </a:ln>
              </c:sp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0-6832-4B51-BE66-E40D148657A9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-1.269002486595239E-16"/>
                  <c:y val="-7.9750784032888308E-2"/>
                </c:manualLayout>
              </c:layout>
              <c:tx>
                <c:rich>
                  <a:bodyPr/>
                  <a:lstStyle/>
                  <a:p>
                    <a:r>
                      <a:rPr lang="en-US" altLang="ko-KR"/>
                      <a:t>#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1-6832-4B51-BE66-E40D148657A9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1.7304779266641074E-3"/>
                  <c:y val="-0.16282451740048029"/>
                </c:manualLayout>
              </c:layout>
              <c:tx>
                <c:rich>
                  <a:bodyPr/>
                  <a:lstStyle/>
                  <a:p>
                    <a:r>
                      <a:rPr lang="en-US" altLang="ko-KR"/>
                      <a:t>#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2-6832-4B51-BE66-E40D148657A9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0"/>
            <c:showCatName val="0"/>
            <c:showSerName val="0"/>
            <c:showPercent val="0"/>
            <c:showBubbleSize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Sheet1!$M$51:$R$51</c:f>
                <c:numCache>
                  <c:formatCode>General</c:formatCode>
                  <c:ptCount val="6"/>
                  <c:pt idx="0">
                    <c:v>38.391941425739155</c:v>
                  </c:pt>
                  <c:pt idx="1">
                    <c:v>36.575839803254311</c:v>
                  </c:pt>
                  <c:pt idx="2">
                    <c:v>18.278503895396007</c:v>
                  </c:pt>
                  <c:pt idx="3">
                    <c:v>38.793117639920403</c:v>
                  </c:pt>
                  <c:pt idx="4">
                    <c:v>28.554262071436444</c:v>
                  </c:pt>
                  <c:pt idx="5">
                    <c:v>60.29263517245507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W$74:$AB$74</c:f>
              <c:strCache>
                <c:ptCount val="6"/>
                <c:pt idx="0">
                  <c:v>Normal</c:v>
                </c:pt>
                <c:pt idx="1">
                  <c:v>GalN</c:v>
                </c:pt>
                <c:pt idx="2">
                  <c:v>Milk thistle 100</c:v>
                </c:pt>
                <c:pt idx="3">
                  <c:v>NSF 25</c:v>
                </c:pt>
                <c:pt idx="4">
                  <c:v>NSF 50</c:v>
                </c:pt>
                <c:pt idx="5">
                  <c:v>NSF 100</c:v>
                </c:pt>
              </c:strCache>
            </c:strRef>
          </c:cat>
          <c:val>
            <c:numRef>
              <c:f>Sheet1!$M$50:$R$50</c:f>
              <c:numCache>
                <c:formatCode>General</c:formatCode>
                <c:ptCount val="6"/>
                <c:pt idx="0">
                  <c:v>181.63336351180342</c:v>
                </c:pt>
                <c:pt idx="1">
                  <c:v>123.4020850976418</c:v>
                </c:pt>
                <c:pt idx="2">
                  <c:v>138.98354823865861</c:v>
                </c:pt>
                <c:pt idx="3">
                  <c:v>148.47118731367959</c:v>
                </c:pt>
                <c:pt idx="4">
                  <c:v>204.87839260321161</c:v>
                </c:pt>
                <c:pt idx="5">
                  <c:v>207.1095341382989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6832-4B51-BE66-E40D148657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764947248"/>
        <c:axId val="1764948336"/>
      </c:barChart>
      <c:catAx>
        <c:axId val="17649472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+mn-lt"/>
              </a:defRPr>
            </a:pPr>
            <a:endParaRPr lang="ko-KR"/>
          </a:p>
        </c:txPr>
        <c:crossAx val="1764948336"/>
        <c:crosses val="autoZero"/>
        <c:auto val="1"/>
        <c:lblAlgn val="ctr"/>
        <c:lblOffset val="100"/>
        <c:noMultiLvlLbl val="0"/>
      </c:catAx>
      <c:valAx>
        <c:axId val="176494833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 dirty="0" err="1"/>
                  <a:t>GPx</a:t>
                </a:r>
                <a:r>
                  <a:rPr lang="en-US" sz="1100" dirty="0"/>
                  <a:t> activity (</a:t>
                </a:r>
                <a:r>
                  <a:rPr lang="en-US" sz="1100" dirty="0" err="1" smtClean="0"/>
                  <a:t>nmol</a:t>
                </a:r>
                <a:r>
                  <a:rPr lang="en-US" sz="1100" dirty="0" smtClean="0"/>
                  <a:t>/</a:t>
                </a:r>
                <a:r>
                  <a:rPr lang="en-US" sz="1100" dirty="0" err="1" smtClean="0"/>
                  <a:t>minl</a:t>
                </a:r>
                <a:r>
                  <a:rPr lang="en-US" sz="1100" dirty="0" smtClean="0"/>
                  <a:t>/mL)</a:t>
                </a:r>
                <a:endParaRPr lang="ko-KR" sz="1100" dirty="0"/>
              </a:p>
            </c:rich>
          </c:tx>
          <c:layout>
            <c:manualLayout>
              <c:xMode val="edge"/>
              <c:yMode val="edge"/>
              <c:x val="2.5207415346750823E-2"/>
              <c:y val="0.17875648148148152"/>
            </c:manualLayout>
          </c:layout>
          <c:overlay val="0"/>
        </c:title>
        <c:numFmt formatCode="#,##0_);[Red]\(#,##0\)" sourceLinked="0"/>
        <c:majorTickMark val="out"/>
        <c:minorTickMark val="none"/>
        <c:tickLblPos val="nextTo"/>
        <c:crossAx val="176494724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+mn-lt"/>
          <a:ea typeface="KT&amp;G 상상본문 L" panose="02000300000000000000" pitchFamily="2" charset="-127"/>
        </a:defRPr>
      </a:pPr>
      <a:endParaRPr lang="ko-KR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5275</cdr:x>
      <cdr:y>0.91901</cdr:y>
    </cdr:from>
    <cdr:to>
      <cdr:x>0.98173</cdr:x>
      <cdr:y>0.9931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4725930" y="2977597"/>
          <a:ext cx="714845" cy="2403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altLang="ko-KR" sz="1100" b="0" dirty="0" smtClean="0">
              <a:latin typeface="+mn-lt"/>
              <a:ea typeface="KT&amp;G 상상본문 L" panose="02000300000000000000" pitchFamily="2" charset="-127"/>
            </a:rPr>
            <a:t>(mg/kg)</a:t>
          </a:r>
          <a:endParaRPr lang="ko-KR" altLang="en-US" sz="1100" b="0" dirty="0">
            <a:latin typeface="+mn-lt"/>
            <a:ea typeface="KT&amp;G 상상본문 L" panose="02000300000000000000" pitchFamily="2" charset="-127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61702F-3159-4176-A549-F57C46F01B3E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0D7359-307D-4F9B-81C4-9B6458800E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73355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7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34" algn="l" defTabSz="91427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270" algn="l" defTabSz="91427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406" algn="l" defTabSz="91427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540" algn="l" defTabSz="91427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675" algn="l" defTabSz="91427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810" algn="l" defTabSz="91427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946" algn="l" defTabSz="91427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081" algn="l" defTabSz="91427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8" indent="0" algn="ctr">
              <a:buNone/>
              <a:defRPr sz="2000"/>
            </a:lvl2pPr>
            <a:lvl3pPr marL="914375" indent="0" algn="ctr">
              <a:buNone/>
              <a:defRPr sz="1800"/>
            </a:lvl3pPr>
            <a:lvl4pPr marL="1371563" indent="0" algn="ctr">
              <a:buNone/>
              <a:defRPr sz="1600"/>
            </a:lvl4pPr>
            <a:lvl5pPr marL="1828750" indent="0" algn="ctr">
              <a:buNone/>
              <a:defRPr sz="1600"/>
            </a:lvl5pPr>
            <a:lvl6pPr marL="2285938" indent="0" algn="ctr">
              <a:buNone/>
              <a:defRPr sz="1600"/>
            </a:lvl6pPr>
            <a:lvl7pPr marL="2743125" indent="0" algn="ctr">
              <a:buNone/>
              <a:defRPr sz="1600"/>
            </a:lvl7pPr>
            <a:lvl8pPr marL="3200312" indent="0" algn="ctr">
              <a:buNone/>
              <a:defRPr sz="1600"/>
            </a:lvl8pPr>
            <a:lvl9pPr marL="3657499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8975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92392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0256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335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8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5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3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2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1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9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84769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1084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8" indent="0">
              <a:buNone/>
              <a:defRPr sz="2000" b="1"/>
            </a:lvl2pPr>
            <a:lvl3pPr marL="914375" indent="0">
              <a:buNone/>
              <a:defRPr sz="1800" b="1"/>
            </a:lvl3pPr>
            <a:lvl4pPr marL="1371563" indent="0">
              <a:buNone/>
              <a:defRPr sz="1600" b="1"/>
            </a:lvl4pPr>
            <a:lvl5pPr marL="1828750" indent="0">
              <a:buNone/>
              <a:defRPr sz="1600" b="1"/>
            </a:lvl5pPr>
            <a:lvl6pPr marL="2285938" indent="0">
              <a:buNone/>
              <a:defRPr sz="1600" b="1"/>
            </a:lvl6pPr>
            <a:lvl7pPr marL="2743125" indent="0">
              <a:buNone/>
              <a:defRPr sz="1600" b="1"/>
            </a:lvl7pPr>
            <a:lvl8pPr marL="3200312" indent="0">
              <a:buNone/>
              <a:defRPr sz="1600" b="1"/>
            </a:lvl8pPr>
            <a:lvl9pPr marL="3657499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8" indent="0">
              <a:buNone/>
              <a:defRPr sz="2000" b="1"/>
            </a:lvl2pPr>
            <a:lvl3pPr marL="914375" indent="0">
              <a:buNone/>
              <a:defRPr sz="1800" b="1"/>
            </a:lvl3pPr>
            <a:lvl4pPr marL="1371563" indent="0">
              <a:buNone/>
              <a:defRPr sz="1600" b="1"/>
            </a:lvl4pPr>
            <a:lvl5pPr marL="1828750" indent="0">
              <a:buNone/>
              <a:defRPr sz="1600" b="1"/>
            </a:lvl5pPr>
            <a:lvl6pPr marL="2285938" indent="0">
              <a:buNone/>
              <a:defRPr sz="1600" b="1"/>
            </a:lvl6pPr>
            <a:lvl7pPr marL="2743125" indent="0">
              <a:buNone/>
              <a:defRPr sz="1600" b="1"/>
            </a:lvl7pPr>
            <a:lvl8pPr marL="3200312" indent="0">
              <a:buNone/>
              <a:defRPr sz="1600" b="1"/>
            </a:lvl8pPr>
            <a:lvl9pPr marL="3657499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5942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5294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790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9" y="2057401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8" indent="0">
              <a:buNone/>
              <a:defRPr sz="1400"/>
            </a:lvl2pPr>
            <a:lvl3pPr marL="914375" indent="0">
              <a:buNone/>
              <a:defRPr sz="1200"/>
            </a:lvl3pPr>
            <a:lvl4pPr marL="1371563" indent="0">
              <a:buNone/>
              <a:defRPr sz="1000"/>
            </a:lvl4pPr>
            <a:lvl5pPr marL="1828750" indent="0">
              <a:buNone/>
              <a:defRPr sz="1000"/>
            </a:lvl5pPr>
            <a:lvl6pPr marL="2285938" indent="0">
              <a:buNone/>
              <a:defRPr sz="1000"/>
            </a:lvl6pPr>
            <a:lvl7pPr marL="2743125" indent="0">
              <a:buNone/>
              <a:defRPr sz="1000"/>
            </a:lvl7pPr>
            <a:lvl8pPr marL="3200312" indent="0">
              <a:buNone/>
              <a:defRPr sz="1000"/>
            </a:lvl8pPr>
            <a:lvl9pPr marL="3657499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42125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88" indent="0">
              <a:buNone/>
              <a:defRPr sz="2800"/>
            </a:lvl2pPr>
            <a:lvl3pPr marL="914375" indent="0">
              <a:buNone/>
              <a:defRPr sz="2400"/>
            </a:lvl3pPr>
            <a:lvl4pPr marL="1371563" indent="0">
              <a:buNone/>
              <a:defRPr sz="2000"/>
            </a:lvl4pPr>
            <a:lvl5pPr marL="1828750" indent="0">
              <a:buNone/>
              <a:defRPr sz="2000"/>
            </a:lvl5pPr>
            <a:lvl6pPr marL="2285938" indent="0">
              <a:buNone/>
              <a:defRPr sz="2000"/>
            </a:lvl6pPr>
            <a:lvl7pPr marL="2743125" indent="0">
              <a:buNone/>
              <a:defRPr sz="2000"/>
            </a:lvl7pPr>
            <a:lvl8pPr marL="3200312" indent="0">
              <a:buNone/>
              <a:defRPr sz="2000"/>
            </a:lvl8pPr>
            <a:lvl9pPr marL="3657499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9" y="2057401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8" indent="0">
              <a:buNone/>
              <a:defRPr sz="1400"/>
            </a:lvl2pPr>
            <a:lvl3pPr marL="914375" indent="0">
              <a:buNone/>
              <a:defRPr sz="1200"/>
            </a:lvl3pPr>
            <a:lvl4pPr marL="1371563" indent="0">
              <a:buNone/>
              <a:defRPr sz="1000"/>
            </a:lvl4pPr>
            <a:lvl5pPr marL="1828750" indent="0">
              <a:buNone/>
              <a:defRPr sz="1000"/>
            </a:lvl5pPr>
            <a:lvl6pPr marL="2285938" indent="0">
              <a:buNone/>
              <a:defRPr sz="1000"/>
            </a:lvl6pPr>
            <a:lvl7pPr marL="2743125" indent="0">
              <a:buNone/>
              <a:defRPr sz="1000"/>
            </a:lvl7pPr>
            <a:lvl8pPr marL="3200312" indent="0">
              <a:buNone/>
              <a:defRPr sz="1000"/>
            </a:lvl8pPr>
            <a:lvl9pPr marL="3657499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786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121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75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5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1" indent="-228594" algn="l" defTabSz="914375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69" indent="-228594" algn="l" defTabSz="914375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56" indent="-228594" algn="l" defTabSz="914375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4" indent="-228594" algn="l" defTabSz="914375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1" indent="-228594" algn="l" defTabSz="914375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18" indent="-228594" algn="l" defTabSz="914375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06" indent="-228594" algn="l" defTabSz="914375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93" indent="-228594" algn="l" defTabSz="914375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375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8" algn="l" defTabSz="914375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5" algn="l" defTabSz="914375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3" algn="l" defTabSz="914375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0" algn="l" defTabSz="914375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38" algn="l" defTabSz="914375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25" algn="l" defTabSz="914375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12" algn="l" defTabSz="914375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99" algn="l" defTabSz="914375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jpeg"/><Relationship Id="rId3" Type="http://schemas.openxmlformats.org/officeDocument/2006/relationships/chart" Target="../charts/chart2.xml"/><Relationship Id="rId7" Type="http://schemas.openxmlformats.org/officeDocument/2006/relationships/image" Target="../media/image2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jpeg"/><Relationship Id="rId11" Type="http://schemas.openxmlformats.org/officeDocument/2006/relationships/image" Target="../media/image6.jpeg"/><Relationship Id="rId5" Type="http://schemas.openxmlformats.org/officeDocument/2006/relationships/chart" Target="../charts/chart4.xml"/><Relationship Id="rId10" Type="http://schemas.openxmlformats.org/officeDocument/2006/relationships/image" Target="../media/image5.jpeg"/><Relationship Id="rId4" Type="http://schemas.openxmlformats.org/officeDocument/2006/relationships/chart" Target="../charts/chart3.xml"/><Relationship Id="rId9" Type="http://schemas.openxmlformats.org/officeDocument/2006/relationships/image" Target="../media/image4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차트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0496807"/>
              </p:ext>
            </p:extLst>
          </p:nvPr>
        </p:nvGraphicFramePr>
        <p:xfrm>
          <a:off x="-2150574" y="553824"/>
          <a:ext cx="5484497" cy="29256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차트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08384166"/>
              </p:ext>
            </p:extLst>
          </p:nvPr>
        </p:nvGraphicFramePr>
        <p:xfrm>
          <a:off x="3117778" y="508601"/>
          <a:ext cx="5425438" cy="29791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차트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33678587"/>
              </p:ext>
            </p:extLst>
          </p:nvPr>
        </p:nvGraphicFramePr>
        <p:xfrm>
          <a:off x="-1962878" y="3452463"/>
          <a:ext cx="5258558" cy="32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차트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83218560"/>
              </p:ext>
            </p:extLst>
          </p:nvPr>
        </p:nvGraphicFramePr>
        <p:xfrm>
          <a:off x="3099931" y="3479501"/>
          <a:ext cx="5542020" cy="32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16" name="그룹 15"/>
          <p:cNvGrpSpPr/>
          <p:nvPr/>
        </p:nvGrpSpPr>
        <p:grpSpPr>
          <a:xfrm>
            <a:off x="8768954" y="213655"/>
            <a:ext cx="5609477" cy="6632711"/>
            <a:chOff x="24566809" y="19016830"/>
            <a:chExt cx="4194047" cy="5388295"/>
          </a:xfrm>
        </p:grpSpPr>
        <p:grpSp>
          <p:nvGrpSpPr>
            <p:cNvPr id="17" name="그룹 16"/>
            <p:cNvGrpSpPr/>
            <p:nvPr/>
          </p:nvGrpSpPr>
          <p:grpSpPr>
            <a:xfrm>
              <a:off x="24566809" y="19016830"/>
              <a:ext cx="2045824" cy="1773053"/>
              <a:chOff x="24409995" y="19016830"/>
              <a:chExt cx="2045824" cy="1773053"/>
            </a:xfrm>
          </p:grpSpPr>
          <p:pic>
            <p:nvPicPr>
              <p:cNvPr id="33" name="그림 32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4409995" y="19016830"/>
                <a:ext cx="2045824" cy="1523020"/>
              </a:xfrm>
              <a:prstGeom prst="rect">
                <a:avLst/>
              </a:prstGeom>
            </p:spPr>
          </p:pic>
          <p:sp>
            <p:nvSpPr>
              <p:cNvPr id="34" name="TextBox 33"/>
              <p:cNvSpPr txBox="1"/>
              <p:nvPr/>
            </p:nvSpPr>
            <p:spPr>
              <a:xfrm>
                <a:off x="24599527" y="20539850"/>
                <a:ext cx="1711357" cy="2500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ea typeface="KT&amp;G 상상본문 L" panose="02000300000000000000" pitchFamily="2" charset="-127"/>
                  </a:rPr>
                  <a:t>Normal</a:t>
                </a:r>
                <a:endParaRPr lang="ko-KR" altLang="en-US" sz="1400" dirty="0">
                  <a:ea typeface="KT&amp;G 상상본문 L" panose="02000300000000000000" pitchFamily="2" charset="-127"/>
                </a:endParaRPr>
              </a:p>
            </p:txBody>
          </p:sp>
        </p:grpSp>
        <p:grpSp>
          <p:nvGrpSpPr>
            <p:cNvPr id="18" name="그룹 17"/>
            <p:cNvGrpSpPr/>
            <p:nvPr/>
          </p:nvGrpSpPr>
          <p:grpSpPr>
            <a:xfrm>
              <a:off x="26715032" y="19020980"/>
              <a:ext cx="2045824" cy="1768902"/>
              <a:chOff x="26715032" y="19020980"/>
              <a:chExt cx="2045824" cy="1768902"/>
            </a:xfrm>
          </p:grpSpPr>
          <p:pic>
            <p:nvPicPr>
              <p:cNvPr id="31" name="그림 30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715032" y="19020980"/>
                <a:ext cx="2045824" cy="1523020"/>
              </a:xfrm>
              <a:prstGeom prst="rect">
                <a:avLst/>
              </a:prstGeom>
            </p:spPr>
          </p:pic>
          <p:sp>
            <p:nvSpPr>
              <p:cNvPr id="32" name="TextBox 31"/>
              <p:cNvSpPr txBox="1"/>
              <p:nvPr/>
            </p:nvSpPr>
            <p:spPr>
              <a:xfrm>
                <a:off x="26882265" y="20539850"/>
                <a:ext cx="1711357" cy="2500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ea typeface="KT&amp;G 상상본문 L" panose="02000300000000000000" pitchFamily="2" charset="-127"/>
                  </a:rPr>
                  <a:t>GalN</a:t>
                </a:r>
                <a:endParaRPr lang="ko-KR" altLang="en-US" sz="1400" dirty="0">
                  <a:ea typeface="KT&amp;G 상상본문 L" panose="02000300000000000000" pitchFamily="2" charset="-127"/>
                </a:endParaRPr>
              </a:p>
            </p:txBody>
          </p:sp>
        </p:grpSp>
        <p:grpSp>
          <p:nvGrpSpPr>
            <p:cNvPr id="19" name="그룹 18"/>
            <p:cNvGrpSpPr/>
            <p:nvPr/>
          </p:nvGrpSpPr>
          <p:grpSpPr>
            <a:xfrm>
              <a:off x="24572383" y="20849693"/>
              <a:ext cx="2040250" cy="1768902"/>
              <a:chOff x="29020067" y="18918732"/>
              <a:chExt cx="2040250" cy="1768902"/>
            </a:xfrm>
          </p:grpSpPr>
          <p:pic>
            <p:nvPicPr>
              <p:cNvPr id="29" name="그림 28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020067" y="18918732"/>
                <a:ext cx="2040250" cy="1518870"/>
              </a:xfrm>
              <a:prstGeom prst="rect">
                <a:avLst/>
              </a:prstGeom>
            </p:spPr>
          </p:pic>
          <p:sp>
            <p:nvSpPr>
              <p:cNvPr id="30" name="TextBox 29"/>
              <p:cNvSpPr txBox="1"/>
              <p:nvPr/>
            </p:nvSpPr>
            <p:spPr>
              <a:xfrm>
                <a:off x="29184514" y="20437602"/>
                <a:ext cx="1711357" cy="2500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ea typeface="KT&amp;G 상상본문 L" panose="02000300000000000000" pitchFamily="2" charset="-127"/>
                  </a:rPr>
                  <a:t>Milk thistle</a:t>
                </a:r>
                <a:r>
                  <a:rPr lang="ko-KR" altLang="en-US" sz="1400" dirty="0">
                    <a:ea typeface="KT&amp;G 상상본문 L" panose="02000300000000000000" pitchFamily="2" charset="-127"/>
                  </a:rPr>
                  <a:t> </a:t>
                </a:r>
                <a:r>
                  <a:rPr lang="en-US" altLang="ko-KR" sz="1400" dirty="0">
                    <a:ea typeface="KT&amp;G 상상본문 L" panose="02000300000000000000" pitchFamily="2" charset="-127"/>
                  </a:rPr>
                  <a:t>100</a:t>
                </a:r>
                <a:endParaRPr lang="ko-KR" altLang="en-US" sz="1400" dirty="0">
                  <a:ea typeface="KT&amp;G 상상본문 L" panose="02000300000000000000" pitchFamily="2" charset="-127"/>
                </a:endParaRPr>
              </a:p>
            </p:txBody>
          </p:sp>
        </p:grpSp>
        <p:grpSp>
          <p:nvGrpSpPr>
            <p:cNvPr id="20" name="그룹 19"/>
            <p:cNvGrpSpPr/>
            <p:nvPr/>
          </p:nvGrpSpPr>
          <p:grpSpPr>
            <a:xfrm>
              <a:off x="26715032" y="20848388"/>
              <a:ext cx="2045824" cy="1773051"/>
              <a:chOff x="24409995" y="20716165"/>
              <a:chExt cx="2045824" cy="1773051"/>
            </a:xfrm>
          </p:grpSpPr>
          <p:pic>
            <p:nvPicPr>
              <p:cNvPr id="27" name="그림 26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4409995" y="20716165"/>
                <a:ext cx="2045824" cy="1523020"/>
              </a:xfrm>
              <a:prstGeom prst="rect">
                <a:avLst/>
              </a:prstGeom>
            </p:spPr>
          </p:pic>
          <p:sp>
            <p:nvSpPr>
              <p:cNvPr id="28" name="TextBox 27"/>
              <p:cNvSpPr txBox="1"/>
              <p:nvPr/>
            </p:nvSpPr>
            <p:spPr>
              <a:xfrm>
                <a:off x="24599527" y="22239184"/>
                <a:ext cx="1711357" cy="2500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ea typeface="KT&amp;G 상상본문 L" panose="02000300000000000000" pitchFamily="2" charset="-127"/>
                  </a:rPr>
                  <a:t>NSF</a:t>
                </a:r>
                <a:r>
                  <a:rPr lang="ko-KR" altLang="en-US" sz="1400" dirty="0">
                    <a:ea typeface="KT&amp;G 상상본문 L" panose="02000300000000000000" pitchFamily="2" charset="-127"/>
                  </a:rPr>
                  <a:t> </a:t>
                </a:r>
                <a:r>
                  <a:rPr lang="en-US" altLang="ko-KR" sz="1400" dirty="0">
                    <a:ea typeface="KT&amp;G 상상본문 L" panose="02000300000000000000" pitchFamily="2" charset="-127"/>
                  </a:rPr>
                  <a:t>25</a:t>
                </a:r>
                <a:endParaRPr lang="ko-KR" altLang="en-US" sz="1400" dirty="0">
                  <a:ea typeface="KT&amp;G 상상본문 L" panose="02000300000000000000" pitchFamily="2" charset="-127"/>
                </a:endParaRPr>
              </a:p>
            </p:txBody>
          </p:sp>
        </p:grpSp>
        <p:grpSp>
          <p:nvGrpSpPr>
            <p:cNvPr id="21" name="그룹 20"/>
            <p:cNvGrpSpPr/>
            <p:nvPr/>
          </p:nvGrpSpPr>
          <p:grpSpPr>
            <a:xfrm>
              <a:off x="24566809" y="22630530"/>
              <a:ext cx="2045824" cy="1773053"/>
              <a:chOff x="26715032" y="20566042"/>
              <a:chExt cx="2045824" cy="1773053"/>
            </a:xfrm>
          </p:grpSpPr>
          <p:pic>
            <p:nvPicPr>
              <p:cNvPr id="25" name="그림 24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715032" y="20566042"/>
                <a:ext cx="2045824" cy="1523020"/>
              </a:xfrm>
              <a:prstGeom prst="rect">
                <a:avLst/>
              </a:prstGeom>
            </p:spPr>
          </p:pic>
          <p:sp>
            <p:nvSpPr>
              <p:cNvPr id="26" name="TextBox 25"/>
              <p:cNvSpPr txBox="1"/>
              <p:nvPr/>
            </p:nvSpPr>
            <p:spPr>
              <a:xfrm>
                <a:off x="26882265" y="22089062"/>
                <a:ext cx="1711357" cy="2500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ea typeface="KT&amp;G 상상본문 L" panose="02000300000000000000" pitchFamily="2" charset="-127"/>
                  </a:rPr>
                  <a:t>NSF</a:t>
                </a:r>
                <a:r>
                  <a:rPr lang="ko-KR" altLang="en-US" sz="1400" dirty="0">
                    <a:ea typeface="KT&amp;G 상상본문 L" panose="02000300000000000000" pitchFamily="2" charset="-127"/>
                  </a:rPr>
                  <a:t> </a:t>
                </a:r>
                <a:r>
                  <a:rPr lang="en-US" altLang="ko-KR" sz="1400" dirty="0">
                    <a:ea typeface="KT&amp;G 상상본문 L" panose="02000300000000000000" pitchFamily="2" charset="-127"/>
                  </a:rPr>
                  <a:t>50</a:t>
                </a:r>
                <a:endParaRPr lang="ko-KR" altLang="en-US" sz="1400" dirty="0">
                  <a:ea typeface="KT&amp;G 상상본문 L" panose="02000300000000000000" pitchFamily="2" charset="-127"/>
                </a:endParaRPr>
              </a:p>
            </p:txBody>
          </p:sp>
        </p:grpSp>
        <p:grpSp>
          <p:nvGrpSpPr>
            <p:cNvPr id="22" name="그룹 21"/>
            <p:cNvGrpSpPr/>
            <p:nvPr/>
          </p:nvGrpSpPr>
          <p:grpSpPr>
            <a:xfrm>
              <a:off x="26715031" y="22632071"/>
              <a:ext cx="2045824" cy="1773054"/>
              <a:chOff x="29020067" y="20566041"/>
              <a:chExt cx="2045824" cy="1773054"/>
            </a:xfrm>
          </p:grpSpPr>
          <p:pic>
            <p:nvPicPr>
              <p:cNvPr id="23" name="그림 22"/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020067" y="20566041"/>
                <a:ext cx="2045824" cy="1523020"/>
              </a:xfrm>
              <a:prstGeom prst="rect">
                <a:avLst/>
              </a:prstGeom>
            </p:spPr>
          </p:pic>
          <p:sp>
            <p:nvSpPr>
              <p:cNvPr id="24" name="TextBox 23"/>
              <p:cNvSpPr txBox="1"/>
              <p:nvPr/>
            </p:nvSpPr>
            <p:spPr>
              <a:xfrm>
                <a:off x="29184514" y="22089062"/>
                <a:ext cx="1711357" cy="2500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ea typeface="KT&amp;G 상상본문 L" panose="02000300000000000000" pitchFamily="2" charset="-127"/>
                  </a:rPr>
                  <a:t>NSF</a:t>
                </a:r>
                <a:r>
                  <a:rPr lang="ko-KR" altLang="en-US" sz="1400" dirty="0">
                    <a:ea typeface="KT&amp;G 상상본문 L" panose="02000300000000000000" pitchFamily="2" charset="-127"/>
                  </a:rPr>
                  <a:t> </a:t>
                </a:r>
                <a:r>
                  <a:rPr lang="en-US" altLang="ko-KR" sz="1400" dirty="0">
                    <a:ea typeface="KT&amp;G 상상본문 L" panose="02000300000000000000" pitchFamily="2" charset="-127"/>
                  </a:rPr>
                  <a:t>100</a:t>
                </a:r>
                <a:endParaRPr lang="ko-KR" altLang="en-US" sz="1400" dirty="0">
                  <a:ea typeface="KT&amp;G 상상본문 L" panose="02000300000000000000" pitchFamily="2" charset="-127"/>
                </a:endParaRPr>
              </a:p>
            </p:txBody>
          </p:sp>
        </p:grpSp>
      </p:grpSp>
      <p:sp>
        <p:nvSpPr>
          <p:cNvPr id="5" name="직사각형 4"/>
          <p:cNvSpPr/>
          <p:nvPr/>
        </p:nvSpPr>
        <p:spPr>
          <a:xfrm>
            <a:off x="-2308979" y="112027"/>
            <a:ext cx="53412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dirty="0">
                <a:ea typeface="KT&amp;G 상상본문 L" panose="020B0600000101010101" pitchFamily="50" charset="-127"/>
                <a:cs typeface="Times New Roman" pitchFamily="18" charset="0"/>
              </a:rPr>
              <a:t>(a)</a:t>
            </a:r>
            <a:endParaRPr lang="ko-KR" altLang="en-US" sz="2551" dirty="0"/>
          </a:p>
        </p:txBody>
      </p:sp>
      <p:sp>
        <p:nvSpPr>
          <p:cNvPr id="6" name="직사각형 5"/>
          <p:cNvSpPr/>
          <p:nvPr/>
        </p:nvSpPr>
        <p:spPr>
          <a:xfrm>
            <a:off x="3048190" y="112030"/>
            <a:ext cx="55816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dirty="0">
                <a:ea typeface="KT&amp;G 상상본문 L" panose="020B0600000101010101" pitchFamily="50" charset="-127"/>
                <a:cs typeface="Times New Roman" pitchFamily="18" charset="0"/>
              </a:rPr>
              <a:t>(b)</a:t>
            </a:r>
            <a:endParaRPr lang="ko-KR" altLang="en-US" sz="2551" dirty="0"/>
          </a:p>
        </p:txBody>
      </p:sp>
      <p:sp>
        <p:nvSpPr>
          <p:cNvPr id="7" name="직사각형 6"/>
          <p:cNvSpPr/>
          <p:nvPr/>
        </p:nvSpPr>
        <p:spPr>
          <a:xfrm>
            <a:off x="3003304" y="3280380"/>
            <a:ext cx="55976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dirty="0">
                <a:ea typeface="KT&amp;G 상상본문 L" panose="020B0600000101010101" pitchFamily="50" charset="-127"/>
                <a:cs typeface="Times New Roman" pitchFamily="18" charset="0"/>
              </a:rPr>
              <a:t>(d)</a:t>
            </a:r>
            <a:endParaRPr lang="ko-KR" altLang="en-US" sz="2551" dirty="0"/>
          </a:p>
        </p:txBody>
      </p:sp>
      <p:sp>
        <p:nvSpPr>
          <p:cNvPr id="10" name="직사각형 9"/>
          <p:cNvSpPr/>
          <p:nvPr/>
        </p:nvSpPr>
        <p:spPr>
          <a:xfrm>
            <a:off x="8169084" y="112030"/>
            <a:ext cx="53893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dirty="0">
                <a:ea typeface="KT&amp;G 상상본문 L" panose="020B0600000101010101" pitchFamily="50" charset="-127"/>
                <a:cs typeface="Times New Roman" pitchFamily="18" charset="0"/>
              </a:rPr>
              <a:t>(e)</a:t>
            </a:r>
            <a:endParaRPr lang="ko-KR" altLang="en-US" sz="2551" dirty="0"/>
          </a:p>
        </p:txBody>
      </p:sp>
      <p:sp>
        <p:nvSpPr>
          <p:cNvPr id="11" name="직사각형 10"/>
          <p:cNvSpPr/>
          <p:nvPr/>
        </p:nvSpPr>
        <p:spPr>
          <a:xfrm>
            <a:off x="-2312185" y="3280379"/>
            <a:ext cx="51969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dirty="0">
                <a:ea typeface="KT&amp;G 상상본문 L" panose="020B0600000101010101" pitchFamily="50" charset="-127"/>
                <a:cs typeface="Times New Roman" pitchFamily="18" charset="0"/>
              </a:rPr>
              <a:t>(c)</a:t>
            </a:r>
            <a:endParaRPr lang="ko-KR" altLang="en-US" sz="2551" dirty="0"/>
          </a:p>
        </p:txBody>
      </p:sp>
      <p:sp>
        <p:nvSpPr>
          <p:cNvPr id="35" name="TextBox 34"/>
          <p:cNvSpPr txBox="1"/>
          <p:nvPr/>
        </p:nvSpPr>
        <p:spPr>
          <a:xfrm>
            <a:off x="1068158" y="3003383"/>
            <a:ext cx="225254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NFP 25    NFP 50   NFP 100</a:t>
            </a:r>
            <a:endParaRPr lang="ko-KR" altLang="en-US" sz="1200" dirty="0"/>
          </a:p>
        </p:txBody>
      </p:sp>
      <p:sp>
        <p:nvSpPr>
          <p:cNvPr id="36" name="TextBox 35"/>
          <p:cNvSpPr txBox="1"/>
          <p:nvPr/>
        </p:nvSpPr>
        <p:spPr>
          <a:xfrm>
            <a:off x="6155699" y="3004879"/>
            <a:ext cx="225254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NFP 25    NFP 50   NFP 100</a:t>
            </a:r>
            <a:endParaRPr lang="ko-KR" altLang="en-US" sz="1200" dirty="0"/>
          </a:p>
        </p:txBody>
      </p:sp>
      <p:sp>
        <p:nvSpPr>
          <p:cNvPr id="37" name="TextBox 36"/>
          <p:cNvSpPr txBox="1"/>
          <p:nvPr/>
        </p:nvSpPr>
        <p:spPr>
          <a:xfrm>
            <a:off x="1013611" y="6173049"/>
            <a:ext cx="225254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NFP 25    NFP 50   NFP 100</a:t>
            </a:r>
            <a:endParaRPr lang="ko-KR" altLang="en-US" sz="1200" dirty="0"/>
          </a:p>
        </p:txBody>
      </p:sp>
      <p:sp>
        <p:nvSpPr>
          <p:cNvPr id="38" name="TextBox 37"/>
          <p:cNvSpPr txBox="1"/>
          <p:nvPr/>
        </p:nvSpPr>
        <p:spPr>
          <a:xfrm>
            <a:off x="6289865" y="6233281"/>
            <a:ext cx="225254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NFP 25    NFP 50   NFP 100</a:t>
            </a:r>
            <a:endParaRPr lang="ko-KR" altLang="en-US" sz="1200" dirty="0"/>
          </a:p>
        </p:txBody>
      </p:sp>
      <p:sp>
        <p:nvSpPr>
          <p:cNvPr id="39" name="TextBox 38"/>
          <p:cNvSpPr txBox="1"/>
          <p:nvPr/>
        </p:nvSpPr>
        <p:spPr>
          <a:xfrm>
            <a:off x="12725078" y="4380284"/>
            <a:ext cx="77136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NFP 25 </a:t>
            </a:r>
            <a:endParaRPr lang="ko-KR" altLang="en-US" sz="1200" dirty="0"/>
          </a:p>
        </p:txBody>
      </p:sp>
      <p:sp>
        <p:nvSpPr>
          <p:cNvPr id="40" name="TextBox 39"/>
          <p:cNvSpPr txBox="1"/>
          <p:nvPr/>
        </p:nvSpPr>
        <p:spPr>
          <a:xfrm>
            <a:off x="9883126" y="6567467"/>
            <a:ext cx="77136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NFP 50 </a:t>
            </a:r>
            <a:endParaRPr lang="ko-KR" altLang="en-US" sz="1200" dirty="0"/>
          </a:p>
        </p:txBody>
      </p:sp>
      <p:sp>
        <p:nvSpPr>
          <p:cNvPr id="41" name="TextBox 40"/>
          <p:cNvSpPr txBox="1"/>
          <p:nvPr/>
        </p:nvSpPr>
        <p:spPr>
          <a:xfrm>
            <a:off x="12620887" y="6581001"/>
            <a:ext cx="86113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NFP 100 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6775834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0630" y="1208227"/>
            <a:ext cx="11541369" cy="47068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65306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1</TotalTime>
  <Words>96</Words>
  <Application>Microsoft Office PowerPoint</Application>
  <PresentationFormat>와이드스크린</PresentationFormat>
  <Paragraphs>39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KT&amp;G 상상본문 L</vt:lpstr>
      <vt:lpstr>맑은 고딕</vt:lpstr>
      <vt:lpstr>Arial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on</dc:creator>
  <cp:lastModifiedBy>Windows 사용자</cp:lastModifiedBy>
  <cp:revision>9</cp:revision>
  <dcterms:created xsi:type="dcterms:W3CDTF">2020-05-11T15:16:05Z</dcterms:created>
  <dcterms:modified xsi:type="dcterms:W3CDTF">2020-06-19T00:57:16Z</dcterms:modified>
</cp:coreProperties>
</file>